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  <p:sldId id="265" r:id="rId3"/>
    <p:sldId id="276" r:id="rId4"/>
    <p:sldId id="256" r:id="rId5"/>
    <p:sldId id="257" r:id="rId6"/>
    <p:sldId id="277" r:id="rId7"/>
    <p:sldId id="266" r:id="rId8"/>
    <p:sldId id="258" r:id="rId9"/>
    <p:sldId id="267" r:id="rId10"/>
    <p:sldId id="264" r:id="rId11"/>
    <p:sldId id="268" r:id="rId12"/>
    <p:sldId id="259" r:id="rId13"/>
    <p:sldId id="261" r:id="rId14"/>
    <p:sldId id="271" r:id="rId15"/>
    <p:sldId id="273" r:id="rId16"/>
    <p:sldId id="262" r:id="rId17"/>
    <p:sldId id="275" r:id="rId18"/>
    <p:sldId id="272" r:id="rId19"/>
    <p:sldId id="270" r:id="rId20"/>
    <p:sldId id="274" r:id="rId21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75" d="100"/>
          <a:sy n="75" d="100"/>
        </p:scale>
        <p:origin x="62" y="11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44A0E76-8833-1E36-9EDE-B9C54312811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5F5BD5A9-A5AD-5257-CFEC-19203D684C9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7F16541-4863-0177-E805-CA85FEA723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676A5-0F56-4CF0-BD02-4EC39FD749A2}" type="datetimeFigureOut">
              <a:rPr lang="zh-CN" altLang="en-US" smtClean="0"/>
              <a:t>2024/8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D9679B3-E56A-964A-B8DA-152375D250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7651954-87BD-4DC1-B7F6-258D6E279E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BCFFBC-831E-48F3-B614-FBAA9A508C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416061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5FC36AD-727E-93D6-BAD8-E3A9D5BE1D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38F373F4-84CC-A9C8-3A12-3197C7A84C5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C067D9A-1C8E-A261-F0CB-D19ECE86A4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676A5-0F56-4CF0-BD02-4EC39FD749A2}" type="datetimeFigureOut">
              <a:rPr lang="zh-CN" altLang="en-US" smtClean="0"/>
              <a:t>2024/8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CCF160B-1C22-23E4-5078-A46BF4C105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2883621-F022-A22A-ACA5-C514D4540C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BCFFBC-831E-48F3-B614-FBAA9A508C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847754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5A69211C-FB83-5448-44B9-3074D6E4661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F9D2E30-2E54-7F0B-4410-D86554EC7DC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7717365-7FBF-4507-EA7D-EF79215825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676A5-0F56-4CF0-BD02-4EC39FD749A2}" type="datetimeFigureOut">
              <a:rPr lang="zh-CN" altLang="en-US" smtClean="0"/>
              <a:t>2024/8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E419062-4535-CD28-BC7B-92EDF948F5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6552E2C-D518-578E-F69D-8373A174DB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BCFFBC-831E-48F3-B614-FBAA9A508C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53404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D5EDA98-F4D8-A1A9-12D8-F3030E7DBC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4A3907A-C4AE-DC67-C648-2B41C6CD25D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FF77FA2-3DDB-B995-7290-15AC2278C2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676A5-0F56-4CF0-BD02-4EC39FD749A2}" type="datetimeFigureOut">
              <a:rPr lang="zh-CN" altLang="en-US" smtClean="0"/>
              <a:t>2024/8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26CB49F-31E1-965A-4B3F-E04B6FBA82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4162A8B-E3FC-DE0D-9ADA-0231CDCC9B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BCFFBC-831E-48F3-B614-FBAA9A508C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44364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FE9B314-7E76-95FA-329D-BE2E153484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B1F9758-A013-2164-5714-E11C32BFF2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8980E4A-954E-98A1-2E8A-5795E5B325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676A5-0F56-4CF0-BD02-4EC39FD749A2}" type="datetimeFigureOut">
              <a:rPr lang="zh-CN" altLang="en-US" smtClean="0"/>
              <a:t>2024/8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7CF8010-AB1E-2976-E6AD-F048C31E31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AED89B0-96D5-2ADB-1947-41BAE0C53A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BCFFBC-831E-48F3-B614-FBAA9A508C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187402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91B64E7-949B-7B99-5E2A-91F27EE69F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67AECB6-EEF7-AB64-AB9C-D8B1FB49AD8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E8925C1-6D0E-1684-90B5-ECFA6B55676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6483FB4-C293-6500-B227-A723354DD7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676A5-0F56-4CF0-BD02-4EC39FD749A2}" type="datetimeFigureOut">
              <a:rPr lang="zh-CN" altLang="en-US" smtClean="0"/>
              <a:t>2024/8/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0E6CB0B-B655-2FAE-10FE-DF24E0BC86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07CF2D9-9C1F-811A-0E0B-5BDB05AB3D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BCFFBC-831E-48F3-B614-FBAA9A508C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243515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35A0E4B-10FC-5ED1-256C-58F0A82CED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AFAC432-26C6-594E-D602-CD0DD19369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F0CCC6C-43F1-4793-E7ED-2EDB9B08014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36AD4F79-4239-8C78-5BCF-1EEE21ED48C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E3D0D28B-DF59-2CCD-39F5-920CA2BDC95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2DE2B967-0059-A9C1-E2EF-F3ACABF96C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676A5-0F56-4CF0-BD02-4EC39FD749A2}" type="datetimeFigureOut">
              <a:rPr lang="zh-CN" altLang="en-US" smtClean="0"/>
              <a:t>2024/8/4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B3C918C0-771C-D349-6132-9B72078502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F7E2A57E-7114-3B07-F82E-F0B9581F9C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BCFFBC-831E-48F3-B614-FBAA9A508C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57795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E9811EA-F236-E967-B3E2-5E7B77034A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32E48810-704C-43E6-D0C1-218B4E2EDA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676A5-0F56-4CF0-BD02-4EC39FD749A2}" type="datetimeFigureOut">
              <a:rPr lang="zh-CN" altLang="en-US" smtClean="0"/>
              <a:t>2024/8/4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6819FDCF-06B4-BCEE-4C86-BD59A5D6DA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8838EDC9-C1A3-02CF-3E03-3CFE5B8720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BCFFBC-831E-48F3-B614-FBAA9A508C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533399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3564BE4C-BB62-1561-F504-4FEBCCAD33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676A5-0F56-4CF0-BD02-4EC39FD749A2}" type="datetimeFigureOut">
              <a:rPr lang="zh-CN" altLang="en-US" smtClean="0"/>
              <a:t>2024/8/4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4C9DD686-8BF1-4F3A-57E0-3F19A73F01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26D1AC3E-0489-8F8A-9985-E176DBD505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BCFFBC-831E-48F3-B614-FBAA9A508C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6563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1F3F904-BE58-BBCE-D5D0-B0A375B737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6DB55CD-F6AD-A637-DA92-3F62311099C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C47E46B-BF19-7B36-20E9-62BF6E64314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3A1B694-B51D-6D37-4EAB-09697B2748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676A5-0F56-4CF0-BD02-4EC39FD749A2}" type="datetimeFigureOut">
              <a:rPr lang="zh-CN" altLang="en-US" smtClean="0"/>
              <a:t>2024/8/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E40031D-F0E6-0179-D404-472AB9126E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84713B3-B246-ADEE-05ED-12FD77E62B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BCFFBC-831E-48F3-B614-FBAA9A508C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052771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F9513CC-4BE3-8C46-BF1B-D052ED7EF5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C4747B99-EAFB-C3CB-F281-BFAB55801C0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B832DF0-6DC2-8A4E-EC41-91CAC0B07D8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3F957B0-9854-3FF1-2650-C66A7F601E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676A5-0F56-4CF0-BD02-4EC39FD749A2}" type="datetimeFigureOut">
              <a:rPr lang="zh-CN" altLang="en-US" smtClean="0"/>
              <a:t>2024/8/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55CBD58-D787-46BE-D8E3-4AB7D488FF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575470C-5643-0AF4-C680-A7210C7529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BCFFBC-831E-48F3-B614-FBAA9A508C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0724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85CF9F05-71D6-DD21-3592-A2D080C91F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FCF2208-BA67-7B27-D579-D8EB78885D6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8342345-C4B2-599F-48EE-BDC0686F60F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6676A5-0F56-4CF0-BD02-4EC39FD749A2}" type="datetimeFigureOut">
              <a:rPr lang="zh-CN" altLang="en-US" smtClean="0"/>
              <a:t>2024/8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2CDD36F-3EBB-0C9E-729D-EC47C5A63F2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CC3E637-2E19-C70B-99EA-1608892CEBF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BCFFBC-831E-48F3-B614-FBAA9A508C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619704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microsoft.com/office/2007/relationships/hdphoto" Target="../media/hdphoto6.wdp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microsoft.com/office/2007/relationships/hdphoto" Target="../media/hdphoto7.wdp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microsoft.com/office/2007/relationships/hdphoto" Target="../media/hdphoto8.wdp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3" Type="http://schemas.microsoft.com/office/2007/relationships/hdphoto" Target="../media/hdphoto9.wdp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3" Type="http://schemas.microsoft.com/office/2007/relationships/hdphoto" Target="../media/hdphoto5.wdp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3" Type="http://schemas.microsoft.com/office/2007/relationships/hdphoto" Target="../media/hdphoto8.wdp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3" Type="http://schemas.microsoft.com/office/2007/relationships/hdphoto" Target="../media/hdphoto10.wdp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3" Type="http://schemas.microsoft.com/office/2007/relationships/hdphoto" Target="../media/hdphoto11.wdp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4" Type="http://schemas.microsoft.com/office/2007/relationships/hdphoto" Target="../media/hdphoto5.wdp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microsoft.com/office/2007/relationships/hdphoto" Target="../media/hdphoto4.wdp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microsoft.com/office/2007/relationships/hdphoto" Target="../media/hdphoto5.wdp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71307FA5-2189-150F-86A3-CE0D0B35F76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35126" y="753321"/>
            <a:ext cx="5756867" cy="4336700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793CC635-8060-A24A-3912-BC7C39119549}"/>
              </a:ext>
            </a:extLst>
          </p:cNvPr>
          <p:cNvSpPr txBox="1"/>
          <p:nvPr/>
        </p:nvSpPr>
        <p:spPr>
          <a:xfrm>
            <a:off x="7089670" y="1514336"/>
            <a:ext cx="121700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1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-92kDa β-catenin</a:t>
            </a:r>
            <a:endParaRPr lang="zh-CN" altLang="zh-CN" sz="11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37F9B49F-622A-0EAC-5EF9-57772D86B711}"/>
              </a:ext>
            </a:extLst>
          </p:cNvPr>
          <p:cNvSpPr txBox="1"/>
          <p:nvPr/>
        </p:nvSpPr>
        <p:spPr>
          <a:xfrm rot="19390089">
            <a:off x="5702118" y="1186053"/>
            <a:ext cx="56938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ontral</a:t>
            </a:r>
            <a:endParaRPr lang="zh-CN" altLang="zh-CN" sz="9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8" name="矩形 7">
            <a:extLst>
              <a:ext uri="{FF2B5EF4-FFF2-40B4-BE49-F238E27FC236}">
                <a16:creationId xmlns:a16="http://schemas.microsoft.com/office/drawing/2014/main" id="{0F02E385-0A48-E618-FA46-C8C83E1B4AB2}"/>
              </a:ext>
            </a:extLst>
          </p:cNvPr>
          <p:cNvSpPr/>
          <p:nvPr/>
        </p:nvSpPr>
        <p:spPr>
          <a:xfrm>
            <a:off x="5795375" y="1497793"/>
            <a:ext cx="409940" cy="18144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BD5F3726-C8CC-7AAB-A582-962E464B7CAC}"/>
              </a:ext>
            </a:extLst>
          </p:cNvPr>
          <p:cNvSpPr txBox="1"/>
          <p:nvPr/>
        </p:nvSpPr>
        <p:spPr>
          <a:xfrm rot="19390089">
            <a:off x="5930240" y="1211582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hROR</a:t>
            </a:r>
            <a:endParaRPr lang="zh-CN" altLang="zh-CN" sz="9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E661DB06-4798-699F-991C-C330E1097BC9}"/>
              </a:ext>
            </a:extLst>
          </p:cNvPr>
          <p:cNvSpPr txBox="1"/>
          <p:nvPr/>
        </p:nvSpPr>
        <p:spPr>
          <a:xfrm>
            <a:off x="2700589" y="731166"/>
            <a:ext cx="8100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1H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511001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图片 11">
            <a:extLst>
              <a:ext uri="{FF2B5EF4-FFF2-40B4-BE49-F238E27FC236}">
                <a16:creationId xmlns:a16="http://schemas.microsoft.com/office/drawing/2014/main" id="{2A056386-D234-FB9B-6584-C2B3B7545E3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0" t="-20" r="-19"/>
          <a:stretch/>
        </p:blipFill>
        <p:spPr>
          <a:xfrm>
            <a:off x="2984590" y="872033"/>
            <a:ext cx="5679451" cy="4279087"/>
          </a:xfrm>
          <a:prstGeom prst="rect">
            <a:avLst/>
          </a:prstGeom>
        </p:spPr>
      </p:pic>
      <p:sp>
        <p:nvSpPr>
          <p:cNvPr id="6" name="矩形 5">
            <a:extLst>
              <a:ext uri="{FF2B5EF4-FFF2-40B4-BE49-F238E27FC236}">
                <a16:creationId xmlns:a16="http://schemas.microsoft.com/office/drawing/2014/main" id="{580A3524-40F6-2CEB-8742-98EC6A7E0209}"/>
              </a:ext>
            </a:extLst>
          </p:cNvPr>
          <p:cNvSpPr/>
          <p:nvPr/>
        </p:nvSpPr>
        <p:spPr>
          <a:xfrm>
            <a:off x="6096000" y="4202495"/>
            <a:ext cx="1137920" cy="25774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" name="文本框 13">
            <a:extLst>
              <a:ext uri="{FF2B5EF4-FFF2-40B4-BE49-F238E27FC236}">
                <a16:creationId xmlns:a16="http://schemas.microsoft.com/office/drawing/2014/main" id="{57B2AA4A-4DFE-A797-31A9-7D816EA25384}"/>
              </a:ext>
            </a:extLst>
          </p:cNvPr>
          <p:cNvSpPr txBox="1"/>
          <p:nvPr/>
        </p:nvSpPr>
        <p:spPr>
          <a:xfrm rot="19390089">
            <a:off x="6359600" y="3908453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b="1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hROR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5" name="文本框 12">
            <a:extLst>
              <a:ext uri="{FF2B5EF4-FFF2-40B4-BE49-F238E27FC236}">
                <a16:creationId xmlns:a16="http://schemas.microsoft.com/office/drawing/2014/main" id="{AFAEDDAF-99C9-68C9-E404-A6DB3F55ECD8}"/>
              </a:ext>
            </a:extLst>
          </p:cNvPr>
          <p:cNvSpPr txBox="1"/>
          <p:nvPr/>
        </p:nvSpPr>
        <p:spPr>
          <a:xfrm rot="19390089">
            <a:off x="6648319" y="3906532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b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vector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7" name="文本框 13">
            <a:extLst>
              <a:ext uri="{FF2B5EF4-FFF2-40B4-BE49-F238E27FC236}">
                <a16:creationId xmlns:a16="http://schemas.microsoft.com/office/drawing/2014/main" id="{91E4363D-EDB7-D733-1717-00DBADDD1EBA}"/>
              </a:ext>
            </a:extLst>
          </p:cNvPr>
          <p:cNvSpPr txBox="1"/>
          <p:nvPr/>
        </p:nvSpPr>
        <p:spPr>
          <a:xfrm rot="19390089">
            <a:off x="6891519" y="3888274"/>
            <a:ext cx="68480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b="1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lincROR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B0263390-3F2F-DF67-A29A-90E54B6B0A38}"/>
              </a:ext>
            </a:extLst>
          </p:cNvPr>
          <p:cNvSpPr txBox="1"/>
          <p:nvPr/>
        </p:nvSpPr>
        <p:spPr>
          <a:xfrm>
            <a:off x="7577167" y="4170241"/>
            <a:ext cx="11599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1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-</a:t>
            </a:r>
            <a:r>
              <a:rPr lang="en-US" altLang="zh-CN" sz="11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44</a:t>
            </a:r>
            <a:r>
              <a:rPr lang="en-US" altLang="zh-CN" sz="11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kDa WNT2B</a:t>
            </a:r>
            <a:endParaRPr lang="zh-CN" altLang="zh-CN" sz="1100" b="1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1" name="文本框 15">
            <a:extLst>
              <a:ext uri="{FF2B5EF4-FFF2-40B4-BE49-F238E27FC236}">
                <a16:creationId xmlns:a16="http://schemas.microsoft.com/office/drawing/2014/main" id="{D2087981-40AC-6867-5E41-66A87B62E6CC}"/>
              </a:ext>
            </a:extLst>
          </p:cNvPr>
          <p:cNvSpPr txBox="1"/>
          <p:nvPr/>
        </p:nvSpPr>
        <p:spPr>
          <a:xfrm>
            <a:off x="2984590" y="872033"/>
            <a:ext cx="8100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3I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4AF044D4-E3E5-25A5-7A41-84088D8554CE}"/>
              </a:ext>
            </a:extLst>
          </p:cNvPr>
          <p:cNvSpPr txBox="1"/>
          <p:nvPr/>
        </p:nvSpPr>
        <p:spPr>
          <a:xfrm rot="19390089">
            <a:off x="6039436" y="3923220"/>
            <a:ext cx="5672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ontrol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0370114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>
            <a:extLst>
              <a:ext uri="{FF2B5EF4-FFF2-40B4-BE49-F238E27FC236}">
                <a16:creationId xmlns:a16="http://schemas.microsoft.com/office/drawing/2014/main" id="{F14F1AD0-35F4-4415-1204-EBCB903E3CE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60916" y="899959"/>
            <a:ext cx="6042077" cy="4551553"/>
          </a:xfrm>
          <a:prstGeom prst="rect">
            <a:avLst/>
          </a:prstGeom>
        </p:spPr>
      </p:pic>
      <p:sp>
        <p:nvSpPr>
          <p:cNvPr id="8" name="矩形 7">
            <a:extLst>
              <a:ext uri="{FF2B5EF4-FFF2-40B4-BE49-F238E27FC236}">
                <a16:creationId xmlns:a16="http://schemas.microsoft.com/office/drawing/2014/main" id="{3779341F-6F6C-ADFC-762C-E886BCB28521}"/>
              </a:ext>
            </a:extLst>
          </p:cNvPr>
          <p:cNvSpPr/>
          <p:nvPr/>
        </p:nvSpPr>
        <p:spPr>
          <a:xfrm>
            <a:off x="6606858" y="2243124"/>
            <a:ext cx="1268509" cy="20731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9" name="文本框 12">
            <a:extLst>
              <a:ext uri="{FF2B5EF4-FFF2-40B4-BE49-F238E27FC236}">
                <a16:creationId xmlns:a16="http://schemas.microsoft.com/office/drawing/2014/main" id="{80E40D36-67A3-D795-AE5B-DF9B7ACE688D}"/>
              </a:ext>
            </a:extLst>
          </p:cNvPr>
          <p:cNvSpPr txBox="1"/>
          <p:nvPr/>
        </p:nvSpPr>
        <p:spPr>
          <a:xfrm rot="19390089">
            <a:off x="6619432" y="1975782"/>
            <a:ext cx="5672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ontrol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0" name="文本框 13">
            <a:extLst>
              <a:ext uri="{FF2B5EF4-FFF2-40B4-BE49-F238E27FC236}">
                <a16:creationId xmlns:a16="http://schemas.microsoft.com/office/drawing/2014/main" id="{CAF84566-A351-8FF9-510F-DD93BB80526D}"/>
              </a:ext>
            </a:extLst>
          </p:cNvPr>
          <p:cNvSpPr txBox="1"/>
          <p:nvPr/>
        </p:nvSpPr>
        <p:spPr>
          <a:xfrm rot="19390089">
            <a:off x="6969200" y="1961666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b="1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hROR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1" name="文本框 12">
            <a:extLst>
              <a:ext uri="{FF2B5EF4-FFF2-40B4-BE49-F238E27FC236}">
                <a16:creationId xmlns:a16="http://schemas.microsoft.com/office/drawing/2014/main" id="{4B87F2F2-09A6-B671-3DCA-FA6A33E8FAF2}"/>
              </a:ext>
            </a:extLst>
          </p:cNvPr>
          <p:cNvSpPr txBox="1"/>
          <p:nvPr/>
        </p:nvSpPr>
        <p:spPr>
          <a:xfrm rot="19390089">
            <a:off x="7257919" y="1959745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b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vector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2" name="文本框 13">
            <a:extLst>
              <a:ext uri="{FF2B5EF4-FFF2-40B4-BE49-F238E27FC236}">
                <a16:creationId xmlns:a16="http://schemas.microsoft.com/office/drawing/2014/main" id="{D16C6335-C794-3B26-A037-E3D2EA1B8B25}"/>
              </a:ext>
            </a:extLst>
          </p:cNvPr>
          <p:cNvSpPr txBox="1"/>
          <p:nvPr/>
        </p:nvSpPr>
        <p:spPr>
          <a:xfrm rot="19390089">
            <a:off x="7556935" y="1940553"/>
            <a:ext cx="68480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b="1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lincROR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7EAFF2DD-9528-7D04-33AF-DD59075D092E}"/>
              </a:ext>
            </a:extLst>
          </p:cNvPr>
          <p:cNvSpPr txBox="1"/>
          <p:nvPr/>
        </p:nvSpPr>
        <p:spPr>
          <a:xfrm>
            <a:off x="8444717" y="2243124"/>
            <a:ext cx="123848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1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-</a:t>
            </a:r>
            <a:r>
              <a:rPr lang="en-US" altLang="zh-CN" sz="11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46</a:t>
            </a:r>
            <a:r>
              <a:rPr lang="en-US" altLang="zh-CN" sz="11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kDa WNT10A</a:t>
            </a:r>
            <a:endParaRPr lang="zh-CN" altLang="zh-CN" sz="11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D7CD91F7-76E6-DC02-3C52-804BCDE94A7F}"/>
              </a:ext>
            </a:extLst>
          </p:cNvPr>
          <p:cNvSpPr txBox="1"/>
          <p:nvPr/>
        </p:nvSpPr>
        <p:spPr>
          <a:xfrm>
            <a:off x="3160916" y="899959"/>
            <a:ext cx="8100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3I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1427541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图片 10">
            <a:extLst>
              <a:ext uri="{FF2B5EF4-FFF2-40B4-BE49-F238E27FC236}">
                <a16:creationId xmlns:a16="http://schemas.microsoft.com/office/drawing/2014/main" id="{379B07C4-6C65-D6B9-135B-5C61CBBC2B4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6" t="-222" r="-61" b="205"/>
          <a:stretch/>
        </p:blipFill>
        <p:spPr>
          <a:xfrm rot="10800000">
            <a:off x="3432296" y="772917"/>
            <a:ext cx="6578489" cy="4956565"/>
          </a:xfrm>
          <a:prstGeom prst="rect">
            <a:avLst/>
          </a:prstGeom>
        </p:spPr>
      </p:pic>
      <p:sp>
        <p:nvSpPr>
          <p:cNvPr id="4" name="矩形 3">
            <a:extLst>
              <a:ext uri="{FF2B5EF4-FFF2-40B4-BE49-F238E27FC236}">
                <a16:creationId xmlns:a16="http://schemas.microsoft.com/office/drawing/2014/main" id="{409ED05A-B5D0-3452-F7B6-29436328E233}"/>
              </a:ext>
            </a:extLst>
          </p:cNvPr>
          <p:cNvSpPr/>
          <p:nvPr/>
        </p:nvSpPr>
        <p:spPr>
          <a:xfrm>
            <a:off x="6105413" y="5010636"/>
            <a:ext cx="1268509" cy="20731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5" name="文本框 13">
            <a:extLst>
              <a:ext uri="{FF2B5EF4-FFF2-40B4-BE49-F238E27FC236}">
                <a16:creationId xmlns:a16="http://schemas.microsoft.com/office/drawing/2014/main" id="{24242931-5D5A-2CFF-56E3-5F6F78534E88}"/>
              </a:ext>
            </a:extLst>
          </p:cNvPr>
          <p:cNvSpPr txBox="1"/>
          <p:nvPr/>
        </p:nvSpPr>
        <p:spPr>
          <a:xfrm rot="19390089">
            <a:off x="6406959" y="4701506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b="1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hROR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6" name="文本框 12">
            <a:extLst>
              <a:ext uri="{FF2B5EF4-FFF2-40B4-BE49-F238E27FC236}">
                <a16:creationId xmlns:a16="http://schemas.microsoft.com/office/drawing/2014/main" id="{F0A11878-9DDA-9A88-8DD6-1E6348A3327A}"/>
              </a:ext>
            </a:extLst>
          </p:cNvPr>
          <p:cNvSpPr txBox="1"/>
          <p:nvPr/>
        </p:nvSpPr>
        <p:spPr>
          <a:xfrm rot="19390089">
            <a:off x="6699747" y="4703428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b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vector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7" name="文本框 13">
            <a:extLst>
              <a:ext uri="{FF2B5EF4-FFF2-40B4-BE49-F238E27FC236}">
                <a16:creationId xmlns:a16="http://schemas.microsoft.com/office/drawing/2014/main" id="{3B456222-3271-6D80-42F1-2EA6C7F2DE39}"/>
              </a:ext>
            </a:extLst>
          </p:cNvPr>
          <p:cNvSpPr txBox="1"/>
          <p:nvPr/>
        </p:nvSpPr>
        <p:spPr>
          <a:xfrm rot="19390089">
            <a:off x="7021300" y="4681328"/>
            <a:ext cx="68480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b="1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lincROR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5C23EA90-AA03-EBA7-7616-EB28D370BA4F}"/>
              </a:ext>
            </a:extLst>
          </p:cNvPr>
          <p:cNvSpPr txBox="1"/>
          <p:nvPr/>
        </p:nvSpPr>
        <p:spPr>
          <a:xfrm>
            <a:off x="7954613" y="4956342"/>
            <a:ext cx="116891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1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-36kDa GAPDH</a:t>
            </a:r>
            <a:endParaRPr lang="zh-CN" altLang="zh-CN" sz="1100" b="1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0" name="文本框 15">
            <a:extLst>
              <a:ext uri="{FF2B5EF4-FFF2-40B4-BE49-F238E27FC236}">
                <a16:creationId xmlns:a16="http://schemas.microsoft.com/office/drawing/2014/main" id="{2B21B602-7F30-7DF7-C049-A9051C3C642D}"/>
              </a:ext>
            </a:extLst>
          </p:cNvPr>
          <p:cNvSpPr txBox="1"/>
          <p:nvPr/>
        </p:nvSpPr>
        <p:spPr>
          <a:xfrm>
            <a:off x="3432296" y="789964"/>
            <a:ext cx="8100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3I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2">
            <a:extLst>
              <a:ext uri="{FF2B5EF4-FFF2-40B4-BE49-F238E27FC236}">
                <a16:creationId xmlns:a16="http://schemas.microsoft.com/office/drawing/2014/main" id="{78B01113-2EED-B9AA-1FC0-9039DE83D1A3}"/>
              </a:ext>
            </a:extLst>
          </p:cNvPr>
          <p:cNvSpPr txBox="1"/>
          <p:nvPr/>
        </p:nvSpPr>
        <p:spPr>
          <a:xfrm rot="19390089">
            <a:off x="6072224" y="4681328"/>
            <a:ext cx="5672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ontrol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5642929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图片 9">
            <a:extLst>
              <a:ext uri="{FF2B5EF4-FFF2-40B4-BE49-F238E27FC236}">
                <a16:creationId xmlns:a16="http://schemas.microsoft.com/office/drawing/2014/main" id="{134CC5AF-FAD2-B585-B6D1-7F78370BD11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0119" y="1142042"/>
            <a:ext cx="6071762" cy="4573915"/>
          </a:xfrm>
          <a:prstGeom prst="rect">
            <a:avLst/>
          </a:prstGeom>
        </p:spPr>
      </p:pic>
      <p:sp>
        <p:nvSpPr>
          <p:cNvPr id="3" name="矩形 2">
            <a:extLst>
              <a:ext uri="{FF2B5EF4-FFF2-40B4-BE49-F238E27FC236}">
                <a16:creationId xmlns:a16="http://schemas.microsoft.com/office/drawing/2014/main" id="{6BDE6649-C11E-3433-079E-9AFEBE436184}"/>
              </a:ext>
            </a:extLst>
          </p:cNvPr>
          <p:cNvSpPr/>
          <p:nvPr/>
        </p:nvSpPr>
        <p:spPr>
          <a:xfrm>
            <a:off x="4831058" y="1716558"/>
            <a:ext cx="1264941" cy="21056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34175EDC-3092-739D-970B-4307221FB428}"/>
              </a:ext>
            </a:extLst>
          </p:cNvPr>
          <p:cNvSpPr txBox="1"/>
          <p:nvPr/>
        </p:nvSpPr>
        <p:spPr>
          <a:xfrm rot="19390089">
            <a:off x="4812107" y="1313883"/>
            <a:ext cx="7889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vector+NC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680BAB9E-4F2E-8901-D18E-E5C92EC7D9F4}"/>
              </a:ext>
            </a:extLst>
          </p:cNvPr>
          <p:cNvSpPr txBox="1"/>
          <p:nvPr/>
        </p:nvSpPr>
        <p:spPr>
          <a:xfrm rot="19390089">
            <a:off x="5095067" y="1275185"/>
            <a:ext cx="10454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vector+miR-145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9AE55D9B-FB9D-96D8-886A-3D8F2467850E}"/>
              </a:ext>
            </a:extLst>
          </p:cNvPr>
          <p:cNvSpPr txBox="1"/>
          <p:nvPr/>
        </p:nvSpPr>
        <p:spPr>
          <a:xfrm rot="19390089">
            <a:off x="5385156" y="1339115"/>
            <a:ext cx="91723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lincROR+NC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2749377D-0788-8EA9-868C-2F0A1FAAEF61}"/>
              </a:ext>
            </a:extLst>
          </p:cNvPr>
          <p:cNvSpPr txBox="1"/>
          <p:nvPr/>
        </p:nvSpPr>
        <p:spPr>
          <a:xfrm rot="19390089">
            <a:off x="5693183" y="1275531"/>
            <a:ext cx="117371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lincROR+miR-145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5BAFA7CE-BFA9-74CD-49DE-C75BD859ED85}"/>
              </a:ext>
            </a:extLst>
          </p:cNvPr>
          <p:cNvSpPr txBox="1"/>
          <p:nvPr/>
        </p:nvSpPr>
        <p:spPr>
          <a:xfrm>
            <a:off x="7366306" y="1716558"/>
            <a:ext cx="11599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1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-</a:t>
            </a:r>
            <a:r>
              <a:rPr lang="en-US" altLang="zh-CN" sz="11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44</a:t>
            </a:r>
            <a:r>
              <a:rPr lang="en-US" altLang="zh-CN" sz="11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kDa WNT2B</a:t>
            </a:r>
            <a:endParaRPr lang="zh-CN" altLang="zh-CN" sz="1100" b="1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5" name="文本框 15">
            <a:extLst>
              <a:ext uri="{FF2B5EF4-FFF2-40B4-BE49-F238E27FC236}">
                <a16:creationId xmlns:a16="http://schemas.microsoft.com/office/drawing/2014/main" id="{DF13E44E-B7A1-A300-8E4A-EA751F50CBC1}"/>
              </a:ext>
            </a:extLst>
          </p:cNvPr>
          <p:cNvSpPr txBox="1"/>
          <p:nvPr/>
        </p:nvSpPr>
        <p:spPr>
          <a:xfrm>
            <a:off x="3094580" y="1142042"/>
            <a:ext cx="8100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4C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9404164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6C178B90-E95D-1580-33CE-117F005FCA0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0265" y="1322795"/>
            <a:ext cx="5888590" cy="4435929"/>
          </a:xfrm>
          <a:prstGeom prst="rect">
            <a:avLst/>
          </a:prstGeom>
        </p:spPr>
      </p:pic>
      <p:sp>
        <p:nvSpPr>
          <p:cNvPr id="4" name="矩形 3">
            <a:extLst>
              <a:ext uri="{FF2B5EF4-FFF2-40B4-BE49-F238E27FC236}">
                <a16:creationId xmlns:a16="http://schemas.microsoft.com/office/drawing/2014/main" id="{3CE117B8-5234-1315-506C-7424658369E0}"/>
              </a:ext>
            </a:extLst>
          </p:cNvPr>
          <p:cNvSpPr/>
          <p:nvPr/>
        </p:nvSpPr>
        <p:spPr>
          <a:xfrm>
            <a:off x="4780259" y="3391155"/>
            <a:ext cx="1264941" cy="21056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CDB57673-BB34-4C9F-2E51-8BA0D3465D09}"/>
              </a:ext>
            </a:extLst>
          </p:cNvPr>
          <p:cNvSpPr txBox="1"/>
          <p:nvPr/>
        </p:nvSpPr>
        <p:spPr>
          <a:xfrm rot="19390089">
            <a:off x="4761308" y="2988480"/>
            <a:ext cx="7889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vector+NC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488029E0-CE31-84EC-8A2E-444A6F812369}"/>
              </a:ext>
            </a:extLst>
          </p:cNvPr>
          <p:cNvSpPr txBox="1"/>
          <p:nvPr/>
        </p:nvSpPr>
        <p:spPr>
          <a:xfrm rot="19390089">
            <a:off x="5044268" y="2949782"/>
            <a:ext cx="10454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vector+miR-145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0D27442E-49E5-EC72-AE8E-8B39DBB99FE3}"/>
              </a:ext>
            </a:extLst>
          </p:cNvPr>
          <p:cNvSpPr txBox="1"/>
          <p:nvPr/>
        </p:nvSpPr>
        <p:spPr>
          <a:xfrm rot="19390089">
            <a:off x="5334357" y="3013712"/>
            <a:ext cx="91723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lincROR+NC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993767A9-BF9B-35DE-D73E-193E5CC31874}"/>
              </a:ext>
            </a:extLst>
          </p:cNvPr>
          <p:cNvSpPr txBox="1"/>
          <p:nvPr/>
        </p:nvSpPr>
        <p:spPr>
          <a:xfrm rot="19390089">
            <a:off x="5642384" y="2950128"/>
            <a:ext cx="117371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lincROR+miR-145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8BC57E70-5ED0-4910-BA72-481D62FF6A12}"/>
              </a:ext>
            </a:extLst>
          </p:cNvPr>
          <p:cNvSpPr txBox="1"/>
          <p:nvPr/>
        </p:nvSpPr>
        <p:spPr>
          <a:xfrm>
            <a:off x="7800607" y="3340138"/>
            <a:ext cx="123848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1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-</a:t>
            </a:r>
            <a:r>
              <a:rPr lang="en-US" altLang="zh-CN" sz="11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46</a:t>
            </a:r>
            <a:r>
              <a:rPr lang="en-US" altLang="zh-CN" sz="11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kDa WNT10A</a:t>
            </a:r>
            <a:endParaRPr lang="zh-CN" altLang="zh-CN" sz="11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1" name="文本框 15">
            <a:extLst>
              <a:ext uri="{FF2B5EF4-FFF2-40B4-BE49-F238E27FC236}">
                <a16:creationId xmlns:a16="http://schemas.microsoft.com/office/drawing/2014/main" id="{2D80F6F9-3391-E192-79A0-ACA93F4B577F}"/>
              </a:ext>
            </a:extLst>
          </p:cNvPr>
          <p:cNvSpPr txBox="1"/>
          <p:nvPr/>
        </p:nvSpPr>
        <p:spPr>
          <a:xfrm>
            <a:off x="3060265" y="1336849"/>
            <a:ext cx="8100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4C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9719633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图片 10">
            <a:extLst>
              <a:ext uri="{FF2B5EF4-FFF2-40B4-BE49-F238E27FC236}">
                <a16:creationId xmlns:a16="http://schemas.microsoft.com/office/drawing/2014/main" id="{C12079A1-0B35-2315-9CE8-86209ABF595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28690" y="1351498"/>
            <a:ext cx="5758726" cy="4338101"/>
          </a:xfrm>
          <a:prstGeom prst="rect">
            <a:avLst/>
          </a:prstGeom>
        </p:spPr>
      </p:pic>
      <p:sp>
        <p:nvSpPr>
          <p:cNvPr id="2" name="矩形 1">
            <a:extLst>
              <a:ext uri="{FF2B5EF4-FFF2-40B4-BE49-F238E27FC236}">
                <a16:creationId xmlns:a16="http://schemas.microsoft.com/office/drawing/2014/main" id="{5BD2FF21-29EB-5DB4-E9BE-79CA7B105724}"/>
              </a:ext>
            </a:extLst>
          </p:cNvPr>
          <p:cNvSpPr/>
          <p:nvPr/>
        </p:nvSpPr>
        <p:spPr>
          <a:xfrm>
            <a:off x="4746679" y="3311426"/>
            <a:ext cx="1227401" cy="16895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A2962DF8-335C-4701-3D1D-158D23AFDA14}"/>
              </a:ext>
            </a:extLst>
          </p:cNvPr>
          <p:cNvSpPr txBox="1"/>
          <p:nvPr/>
        </p:nvSpPr>
        <p:spPr>
          <a:xfrm rot="19390089">
            <a:off x="4690188" y="2921042"/>
            <a:ext cx="7889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vector+NC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4888CFD6-033D-B8E2-D798-4F3515127B26}"/>
              </a:ext>
            </a:extLst>
          </p:cNvPr>
          <p:cNvSpPr txBox="1"/>
          <p:nvPr/>
        </p:nvSpPr>
        <p:spPr>
          <a:xfrm rot="19390089">
            <a:off x="4973148" y="2882344"/>
            <a:ext cx="10454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vector+miR-145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9D94D6C3-45E3-5E42-9986-2AD7D468812A}"/>
              </a:ext>
            </a:extLst>
          </p:cNvPr>
          <p:cNvSpPr txBox="1"/>
          <p:nvPr/>
        </p:nvSpPr>
        <p:spPr>
          <a:xfrm rot="19390089">
            <a:off x="5263237" y="2946274"/>
            <a:ext cx="91723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lincROR+NC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DDD22851-C6C5-5821-1A03-FBA2BE089264}"/>
              </a:ext>
            </a:extLst>
          </p:cNvPr>
          <p:cNvSpPr txBox="1"/>
          <p:nvPr/>
        </p:nvSpPr>
        <p:spPr>
          <a:xfrm rot="19390089">
            <a:off x="5571264" y="2882690"/>
            <a:ext cx="117371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lincROR+miR-145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2" name="文本框 1">
            <a:extLst>
              <a:ext uri="{FF2B5EF4-FFF2-40B4-BE49-F238E27FC236}">
                <a16:creationId xmlns:a16="http://schemas.microsoft.com/office/drawing/2014/main" id="{36CD7AA1-0D55-E138-8CCA-38377B5F7890}"/>
              </a:ext>
            </a:extLst>
          </p:cNvPr>
          <p:cNvSpPr txBox="1"/>
          <p:nvPr/>
        </p:nvSpPr>
        <p:spPr>
          <a:xfrm>
            <a:off x="7575068" y="3251840"/>
            <a:ext cx="1161928" cy="2497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1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-92kDa β-catenin</a:t>
            </a:r>
            <a:endParaRPr lang="zh-CN" altLang="zh-CN" sz="11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3" name="文本框 15">
            <a:extLst>
              <a:ext uri="{FF2B5EF4-FFF2-40B4-BE49-F238E27FC236}">
                <a16:creationId xmlns:a16="http://schemas.microsoft.com/office/drawing/2014/main" id="{A646CB2F-F1A0-09E0-F0C3-B32080CBC148}"/>
              </a:ext>
            </a:extLst>
          </p:cNvPr>
          <p:cNvSpPr txBox="1"/>
          <p:nvPr/>
        </p:nvSpPr>
        <p:spPr>
          <a:xfrm>
            <a:off x="2828690" y="1351498"/>
            <a:ext cx="8100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4C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6172820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图片 7">
            <a:extLst>
              <a:ext uri="{FF2B5EF4-FFF2-40B4-BE49-F238E27FC236}">
                <a16:creationId xmlns:a16="http://schemas.microsoft.com/office/drawing/2014/main" id="{EC3C7331-21BF-0ED4-ABD8-A8F85894809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97061" y="1559573"/>
            <a:ext cx="5699899" cy="4293785"/>
          </a:xfrm>
          <a:prstGeom prst="rect">
            <a:avLst/>
          </a:prstGeom>
        </p:spPr>
      </p:pic>
      <p:sp>
        <p:nvSpPr>
          <p:cNvPr id="6" name="矩形 5">
            <a:extLst>
              <a:ext uri="{FF2B5EF4-FFF2-40B4-BE49-F238E27FC236}">
                <a16:creationId xmlns:a16="http://schemas.microsoft.com/office/drawing/2014/main" id="{92361BC9-0371-0CC6-2B4B-827CEB370E6A}"/>
              </a:ext>
            </a:extLst>
          </p:cNvPr>
          <p:cNvSpPr/>
          <p:nvPr/>
        </p:nvSpPr>
        <p:spPr>
          <a:xfrm>
            <a:off x="5042826" y="3754623"/>
            <a:ext cx="1109185" cy="18350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1A140887-A962-E03A-388C-BB76CD490524}"/>
              </a:ext>
            </a:extLst>
          </p:cNvPr>
          <p:cNvSpPr txBox="1"/>
          <p:nvPr/>
        </p:nvSpPr>
        <p:spPr>
          <a:xfrm rot="19390089">
            <a:off x="5010713" y="3381007"/>
            <a:ext cx="8153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vector+NC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A2342A1F-3B62-B399-9579-AD6565D167DB}"/>
              </a:ext>
            </a:extLst>
          </p:cNvPr>
          <p:cNvSpPr txBox="1"/>
          <p:nvPr/>
        </p:nvSpPr>
        <p:spPr>
          <a:xfrm rot="19390089">
            <a:off x="5302435" y="3301565"/>
            <a:ext cx="108038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vector+miR-145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1D572A86-DF48-E5E2-0501-AC6A85828F6F}"/>
              </a:ext>
            </a:extLst>
          </p:cNvPr>
          <p:cNvSpPr txBox="1"/>
          <p:nvPr/>
        </p:nvSpPr>
        <p:spPr>
          <a:xfrm rot="19390089">
            <a:off x="5592952" y="3366778"/>
            <a:ext cx="9478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lincROR+NC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21AD5E20-A969-F8D2-1E8F-8EC4AFD332D4}"/>
              </a:ext>
            </a:extLst>
          </p:cNvPr>
          <p:cNvSpPr txBox="1"/>
          <p:nvPr/>
        </p:nvSpPr>
        <p:spPr>
          <a:xfrm rot="19390089">
            <a:off x="5900124" y="3300628"/>
            <a:ext cx="12129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lincROR+miR-145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D9D4A729-E69C-BAEA-6088-10BCE599C7F3}"/>
              </a:ext>
            </a:extLst>
          </p:cNvPr>
          <p:cNvSpPr txBox="1"/>
          <p:nvPr/>
        </p:nvSpPr>
        <p:spPr>
          <a:xfrm>
            <a:off x="7666161" y="3807319"/>
            <a:ext cx="116891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1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-36kDa GAPDH</a:t>
            </a:r>
            <a:endParaRPr lang="zh-CN" altLang="zh-CN" sz="1100" b="1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5" name="文本框 15">
            <a:extLst>
              <a:ext uri="{FF2B5EF4-FFF2-40B4-BE49-F238E27FC236}">
                <a16:creationId xmlns:a16="http://schemas.microsoft.com/office/drawing/2014/main" id="{87C33718-755C-24C5-D4CC-8B6ED9EA390A}"/>
              </a:ext>
            </a:extLst>
          </p:cNvPr>
          <p:cNvSpPr txBox="1"/>
          <p:nvPr/>
        </p:nvSpPr>
        <p:spPr>
          <a:xfrm>
            <a:off x="2997061" y="1559573"/>
            <a:ext cx="8100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4C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08435490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图片 9">
            <a:extLst>
              <a:ext uri="{FF2B5EF4-FFF2-40B4-BE49-F238E27FC236}">
                <a16:creationId xmlns:a16="http://schemas.microsoft.com/office/drawing/2014/main" id="{134CC5AF-FAD2-B585-B6D1-7F78370BD11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0119" y="1142042"/>
            <a:ext cx="6071762" cy="4573915"/>
          </a:xfrm>
          <a:prstGeom prst="rect">
            <a:avLst/>
          </a:prstGeom>
        </p:spPr>
      </p:pic>
      <p:sp>
        <p:nvSpPr>
          <p:cNvPr id="5" name="矩形 4">
            <a:extLst>
              <a:ext uri="{FF2B5EF4-FFF2-40B4-BE49-F238E27FC236}">
                <a16:creationId xmlns:a16="http://schemas.microsoft.com/office/drawing/2014/main" id="{5A5E2251-3414-5159-5202-11CD81C65966}"/>
              </a:ext>
            </a:extLst>
          </p:cNvPr>
          <p:cNvSpPr/>
          <p:nvPr/>
        </p:nvSpPr>
        <p:spPr>
          <a:xfrm>
            <a:off x="5927354" y="4955459"/>
            <a:ext cx="1264941" cy="21056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16000626-517C-7972-9FCF-2B880615815B}"/>
              </a:ext>
            </a:extLst>
          </p:cNvPr>
          <p:cNvSpPr txBox="1"/>
          <p:nvPr/>
        </p:nvSpPr>
        <p:spPr>
          <a:xfrm rot="19390089">
            <a:off x="5774511" y="4526205"/>
            <a:ext cx="101983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vector+anti-NC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4E2F8370-8223-8C19-A551-4C5C7ACB8D7D}"/>
              </a:ext>
            </a:extLst>
          </p:cNvPr>
          <p:cNvSpPr txBox="1"/>
          <p:nvPr/>
        </p:nvSpPr>
        <p:spPr>
          <a:xfrm rot="19390089">
            <a:off x="6088418" y="4420898"/>
            <a:ext cx="127631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vector+anti-miR-145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E3235122-97A8-9D6D-623F-3CBA13B41F07}"/>
              </a:ext>
            </a:extLst>
          </p:cNvPr>
          <p:cNvSpPr txBox="1"/>
          <p:nvPr/>
        </p:nvSpPr>
        <p:spPr>
          <a:xfrm rot="19390089">
            <a:off x="6406475" y="4466375"/>
            <a:ext cx="11480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lincROR+anti-NC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AF0A299B-681E-E0A5-033F-3C6C963A8803}"/>
              </a:ext>
            </a:extLst>
          </p:cNvPr>
          <p:cNvSpPr txBox="1"/>
          <p:nvPr/>
        </p:nvSpPr>
        <p:spPr>
          <a:xfrm rot="19390089">
            <a:off x="6747967" y="4431955"/>
            <a:ext cx="140455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lincROR+anti-miR-145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D177F25A-C705-FB8B-BBFC-378C906A3AAF}"/>
              </a:ext>
            </a:extLst>
          </p:cNvPr>
          <p:cNvSpPr txBox="1"/>
          <p:nvPr/>
        </p:nvSpPr>
        <p:spPr>
          <a:xfrm>
            <a:off x="7366306" y="4961351"/>
            <a:ext cx="11599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1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-</a:t>
            </a:r>
            <a:r>
              <a:rPr lang="en-US" altLang="zh-CN" sz="11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44</a:t>
            </a:r>
            <a:r>
              <a:rPr lang="en-US" altLang="zh-CN" sz="11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kDa WNT2B</a:t>
            </a:r>
            <a:endParaRPr lang="zh-CN" altLang="zh-CN" sz="1100" b="1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" name="文本框 15">
            <a:extLst>
              <a:ext uri="{FF2B5EF4-FFF2-40B4-BE49-F238E27FC236}">
                <a16:creationId xmlns:a16="http://schemas.microsoft.com/office/drawing/2014/main" id="{C9666270-C153-2DD9-54B8-1DB7B3AA4435}"/>
              </a:ext>
            </a:extLst>
          </p:cNvPr>
          <p:cNvSpPr txBox="1"/>
          <p:nvPr/>
        </p:nvSpPr>
        <p:spPr>
          <a:xfrm>
            <a:off x="3094580" y="1142042"/>
            <a:ext cx="8100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4C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92570445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4F46B714-2F01-9D53-BC62-911FE8B0C83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03051" y="970012"/>
            <a:ext cx="5850572" cy="4407290"/>
          </a:xfrm>
          <a:prstGeom prst="rect">
            <a:avLst/>
          </a:prstGeom>
        </p:spPr>
      </p:pic>
      <p:sp>
        <p:nvSpPr>
          <p:cNvPr id="4" name="矩形 3">
            <a:extLst>
              <a:ext uri="{FF2B5EF4-FFF2-40B4-BE49-F238E27FC236}">
                <a16:creationId xmlns:a16="http://schemas.microsoft.com/office/drawing/2014/main" id="{CF24E429-7123-6F86-DDA7-FAF00E97DA48}"/>
              </a:ext>
            </a:extLst>
          </p:cNvPr>
          <p:cNvSpPr/>
          <p:nvPr/>
        </p:nvSpPr>
        <p:spPr>
          <a:xfrm>
            <a:off x="5463530" y="2179026"/>
            <a:ext cx="1159936" cy="19621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AE596B84-5E1C-F1B2-47DD-92BA7AF2D6AB}"/>
              </a:ext>
            </a:extLst>
          </p:cNvPr>
          <p:cNvSpPr txBox="1"/>
          <p:nvPr/>
        </p:nvSpPr>
        <p:spPr>
          <a:xfrm rot="19390089">
            <a:off x="5333043" y="1756785"/>
            <a:ext cx="101983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vector+anti-NC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F564DE51-102D-F32A-8F61-383F60C9C06D}"/>
              </a:ext>
            </a:extLst>
          </p:cNvPr>
          <p:cNvSpPr txBox="1"/>
          <p:nvPr/>
        </p:nvSpPr>
        <p:spPr>
          <a:xfrm rot="19390089">
            <a:off x="5646950" y="1651478"/>
            <a:ext cx="127631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vector+anti-miR-145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4EEBAA2E-330A-13EA-C62E-7AED719A8202}"/>
              </a:ext>
            </a:extLst>
          </p:cNvPr>
          <p:cNvSpPr txBox="1"/>
          <p:nvPr/>
        </p:nvSpPr>
        <p:spPr>
          <a:xfrm rot="19390089">
            <a:off x="5965007" y="1696955"/>
            <a:ext cx="11480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lincROR+anti-NC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B2EF60F6-16CF-D98A-A148-E5341ABD0902}"/>
              </a:ext>
            </a:extLst>
          </p:cNvPr>
          <p:cNvSpPr txBox="1"/>
          <p:nvPr/>
        </p:nvSpPr>
        <p:spPr>
          <a:xfrm rot="19390089">
            <a:off x="6306499" y="1662535"/>
            <a:ext cx="140455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lincROR+anti-miR-145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1" name="文本框 15">
            <a:extLst>
              <a:ext uri="{FF2B5EF4-FFF2-40B4-BE49-F238E27FC236}">
                <a16:creationId xmlns:a16="http://schemas.microsoft.com/office/drawing/2014/main" id="{A02D61F2-2784-0E2F-27FE-261C71BF2BCE}"/>
              </a:ext>
            </a:extLst>
          </p:cNvPr>
          <p:cNvSpPr txBox="1"/>
          <p:nvPr/>
        </p:nvSpPr>
        <p:spPr>
          <a:xfrm>
            <a:off x="3003051" y="970012"/>
            <a:ext cx="8100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4C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11646B9B-3BC0-0184-4810-8AA9B52047DB}"/>
              </a:ext>
            </a:extLst>
          </p:cNvPr>
          <p:cNvSpPr txBox="1"/>
          <p:nvPr/>
        </p:nvSpPr>
        <p:spPr>
          <a:xfrm>
            <a:off x="6990555" y="2202475"/>
            <a:ext cx="123848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1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-</a:t>
            </a:r>
            <a:r>
              <a:rPr lang="en-US" altLang="zh-CN" sz="11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46</a:t>
            </a:r>
            <a:r>
              <a:rPr lang="en-US" altLang="zh-CN" sz="11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kDa WNT10A</a:t>
            </a:r>
            <a:endParaRPr lang="zh-CN" altLang="zh-CN" sz="11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82364586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id="{C66BC09C-9168-0B50-E254-174BE684C63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04000" y="1352532"/>
            <a:ext cx="5730380" cy="4316748"/>
          </a:xfrm>
          <a:prstGeom prst="rect">
            <a:avLst/>
          </a:prstGeom>
        </p:spPr>
      </p:pic>
      <p:sp>
        <p:nvSpPr>
          <p:cNvPr id="3" name="矩形 2">
            <a:extLst>
              <a:ext uri="{FF2B5EF4-FFF2-40B4-BE49-F238E27FC236}">
                <a16:creationId xmlns:a16="http://schemas.microsoft.com/office/drawing/2014/main" id="{9997D1C6-ED46-559A-79D9-687B2C3E75A9}"/>
              </a:ext>
            </a:extLst>
          </p:cNvPr>
          <p:cNvSpPr/>
          <p:nvPr/>
        </p:nvSpPr>
        <p:spPr>
          <a:xfrm>
            <a:off x="6173612" y="3093884"/>
            <a:ext cx="1168282" cy="21827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2B70E516-4561-DDBD-C464-080DD36EC0B3}"/>
              </a:ext>
            </a:extLst>
          </p:cNvPr>
          <p:cNvSpPr txBox="1"/>
          <p:nvPr/>
        </p:nvSpPr>
        <p:spPr>
          <a:xfrm rot="19390089">
            <a:off x="5985796" y="2650786"/>
            <a:ext cx="101983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vector+anti-NC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875F54A8-9FC4-DAFB-8491-A597DE68B4D4}"/>
              </a:ext>
            </a:extLst>
          </p:cNvPr>
          <p:cNvSpPr txBox="1"/>
          <p:nvPr/>
        </p:nvSpPr>
        <p:spPr>
          <a:xfrm rot="19390089">
            <a:off x="6299703" y="2545479"/>
            <a:ext cx="127631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vector+anti-miR-145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158C09C9-CA6F-0867-8B7D-3A64D744261F}"/>
              </a:ext>
            </a:extLst>
          </p:cNvPr>
          <p:cNvSpPr txBox="1"/>
          <p:nvPr/>
        </p:nvSpPr>
        <p:spPr>
          <a:xfrm rot="19390089">
            <a:off x="6617760" y="2590956"/>
            <a:ext cx="11480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lincROR+anti-NC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28812431-ED23-8B58-847E-1DADE23204C1}"/>
              </a:ext>
            </a:extLst>
          </p:cNvPr>
          <p:cNvSpPr txBox="1"/>
          <p:nvPr/>
        </p:nvSpPr>
        <p:spPr>
          <a:xfrm rot="19390089">
            <a:off x="6959252" y="2556536"/>
            <a:ext cx="140455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lincROR+anti-miR-145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0" name="文本框 1">
            <a:extLst>
              <a:ext uri="{FF2B5EF4-FFF2-40B4-BE49-F238E27FC236}">
                <a16:creationId xmlns:a16="http://schemas.microsoft.com/office/drawing/2014/main" id="{9F951853-D580-BFD0-7E72-B4D185EEF7DB}"/>
              </a:ext>
            </a:extLst>
          </p:cNvPr>
          <p:cNvSpPr txBox="1"/>
          <p:nvPr/>
        </p:nvSpPr>
        <p:spPr>
          <a:xfrm>
            <a:off x="7625435" y="3093884"/>
            <a:ext cx="1161928" cy="2497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1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-92kDa β-catenin</a:t>
            </a:r>
            <a:endParaRPr lang="zh-CN" altLang="zh-CN" sz="11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1" name="文本框 15">
            <a:extLst>
              <a:ext uri="{FF2B5EF4-FFF2-40B4-BE49-F238E27FC236}">
                <a16:creationId xmlns:a16="http://schemas.microsoft.com/office/drawing/2014/main" id="{8493B47C-68EB-2836-BABF-269494D4D5C8}"/>
              </a:ext>
            </a:extLst>
          </p:cNvPr>
          <p:cNvSpPr txBox="1"/>
          <p:nvPr/>
        </p:nvSpPr>
        <p:spPr>
          <a:xfrm>
            <a:off x="3504000" y="1352532"/>
            <a:ext cx="8100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4C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349881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图片 9">
            <a:extLst>
              <a:ext uri="{FF2B5EF4-FFF2-40B4-BE49-F238E27FC236}">
                <a16:creationId xmlns:a16="http://schemas.microsoft.com/office/drawing/2014/main" id="{EF214681-A900-7672-E3D5-F77651B9E69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35126" y="753321"/>
            <a:ext cx="5756867" cy="4336700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FE4E45D5-A81E-3A13-BB81-6CD20DE7DC44}"/>
              </a:ext>
            </a:extLst>
          </p:cNvPr>
          <p:cNvSpPr txBox="1"/>
          <p:nvPr/>
        </p:nvSpPr>
        <p:spPr>
          <a:xfrm>
            <a:off x="7077052" y="2234056"/>
            <a:ext cx="116891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1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-36kDa GAPDH</a:t>
            </a:r>
            <a:endParaRPr lang="zh-CN" altLang="zh-CN" sz="1100" b="1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1E5D0E1E-3714-E067-2B7D-655BA0124F03}"/>
              </a:ext>
            </a:extLst>
          </p:cNvPr>
          <p:cNvSpPr txBox="1"/>
          <p:nvPr/>
        </p:nvSpPr>
        <p:spPr>
          <a:xfrm rot="19390089">
            <a:off x="5728966" y="1955412"/>
            <a:ext cx="56938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ontral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" name="矩形 2">
            <a:extLst>
              <a:ext uri="{FF2B5EF4-FFF2-40B4-BE49-F238E27FC236}">
                <a16:creationId xmlns:a16="http://schemas.microsoft.com/office/drawing/2014/main" id="{466786D5-E1B8-4267-54E7-9D14E846C824}"/>
              </a:ext>
            </a:extLst>
          </p:cNvPr>
          <p:cNvSpPr/>
          <p:nvPr/>
        </p:nvSpPr>
        <p:spPr>
          <a:xfrm>
            <a:off x="5798974" y="2286130"/>
            <a:ext cx="371793" cy="15746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719F0B18-E7CD-AABB-6EF2-FB00588F433B}"/>
              </a:ext>
            </a:extLst>
          </p:cNvPr>
          <p:cNvSpPr txBox="1"/>
          <p:nvPr/>
        </p:nvSpPr>
        <p:spPr>
          <a:xfrm rot="19390089">
            <a:off x="5967445" y="1982151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hROR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9928D7B2-5CFA-45EF-AF02-AE305DF3CCA7}"/>
              </a:ext>
            </a:extLst>
          </p:cNvPr>
          <p:cNvSpPr txBox="1"/>
          <p:nvPr/>
        </p:nvSpPr>
        <p:spPr>
          <a:xfrm>
            <a:off x="2700589" y="731166"/>
            <a:ext cx="8100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1H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7575326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4C22080E-A0C0-6458-084F-60C96A21D0D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97061" y="1559573"/>
            <a:ext cx="5699899" cy="4293785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C850DF15-E5F3-3B49-D7CE-664B028F51B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49461" y="1711973"/>
            <a:ext cx="5699899" cy="4293785"/>
          </a:xfrm>
          <a:prstGeom prst="rect">
            <a:avLst/>
          </a:prstGeom>
        </p:spPr>
      </p:pic>
      <p:sp>
        <p:nvSpPr>
          <p:cNvPr id="5" name="矩形 4">
            <a:extLst>
              <a:ext uri="{FF2B5EF4-FFF2-40B4-BE49-F238E27FC236}">
                <a16:creationId xmlns:a16="http://schemas.microsoft.com/office/drawing/2014/main" id="{24CC7B51-FA23-2C64-5FD2-6C3F33EF44B2}"/>
              </a:ext>
            </a:extLst>
          </p:cNvPr>
          <p:cNvSpPr/>
          <p:nvPr/>
        </p:nvSpPr>
        <p:spPr>
          <a:xfrm>
            <a:off x="6347450" y="4627586"/>
            <a:ext cx="1159936" cy="19621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D25DAC30-116D-287D-A4DA-1F0D42E2F9BA}"/>
              </a:ext>
            </a:extLst>
          </p:cNvPr>
          <p:cNvSpPr txBox="1"/>
          <p:nvPr/>
        </p:nvSpPr>
        <p:spPr>
          <a:xfrm rot="19390089">
            <a:off x="6216963" y="4205345"/>
            <a:ext cx="101983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vector+anti-NC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3E331819-B191-16D5-1A8A-731D5AB4CB05}"/>
              </a:ext>
            </a:extLst>
          </p:cNvPr>
          <p:cNvSpPr txBox="1"/>
          <p:nvPr/>
        </p:nvSpPr>
        <p:spPr>
          <a:xfrm rot="19390089">
            <a:off x="6530870" y="4100038"/>
            <a:ext cx="127631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vector+anti-miR-145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FBEA01C9-1056-0562-5009-4C8A6CEC9F73}"/>
              </a:ext>
            </a:extLst>
          </p:cNvPr>
          <p:cNvSpPr txBox="1"/>
          <p:nvPr/>
        </p:nvSpPr>
        <p:spPr>
          <a:xfrm rot="19390089">
            <a:off x="6848927" y="4145515"/>
            <a:ext cx="11480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lincROR+anti-NC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DD7EAC90-E0DD-3997-CC6D-380F5DAEB841}"/>
              </a:ext>
            </a:extLst>
          </p:cNvPr>
          <p:cNvSpPr txBox="1"/>
          <p:nvPr/>
        </p:nvSpPr>
        <p:spPr>
          <a:xfrm rot="19390089">
            <a:off x="7190419" y="4111095"/>
            <a:ext cx="140455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lincROR+anti-miR-145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B92C893A-62F1-ACF2-F81F-6A42A1498111}"/>
              </a:ext>
            </a:extLst>
          </p:cNvPr>
          <p:cNvSpPr txBox="1"/>
          <p:nvPr/>
        </p:nvSpPr>
        <p:spPr>
          <a:xfrm>
            <a:off x="8008811" y="4562187"/>
            <a:ext cx="116891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1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-36kDa GAPDH</a:t>
            </a:r>
            <a:endParaRPr lang="zh-CN" altLang="zh-CN" sz="1100" b="1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1" name="文本框 15">
            <a:extLst>
              <a:ext uri="{FF2B5EF4-FFF2-40B4-BE49-F238E27FC236}">
                <a16:creationId xmlns:a16="http://schemas.microsoft.com/office/drawing/2014/main" id="{8C072837-1CC4-792E-A1C7-D151B47B6ED7}"/>
              </a:ext>
            </a:extLst>
          </p:cNvPr>
          <p:cNvSpPr txBox="1"/>
          <p:nvPr/>
        </p:nvSpPr>
        <p:spPr>
          <a:xfrm>
            <a:off x="3149461" y="1711973"/>
            <a:ext cx="8100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4C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6558452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2020-10-01_04-36-33_8bit">
            <a:extLst>
              <a:ext uri="{FF2B5EF4-FFF2-40B4-BE49-F238E27FC236}">
                <a16:creationId xmlns:a16="http://schemas.microsoft.com/office/drawing/2014/main" id="{25D9DBB7-546C-BC32-AD96-B11F2C53991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lum contrast="-18000"/>
          </a:blip>
          <a:srcRect l="-108" t="249" r="123" b="-271"/>
          <a:stretch/>
        </p:blipFill>
        <p:spPr>
          <a:xfrm>
            <a:off x="1731261" y="1884569"/>
            <a:ext cx="8254800" cy="1998000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4E822C1F-D73E-6FDB-9828-C4F8DA1B96D1}"/>
              </a:ext>
            </a:extLst>
          </p:cNvPr>
          <p:cNvSpPr txBox="1"/>
          <p:nvPr/>
        </p:nvSpPr>
        <p:spPr>
          <a:xfrm rot="19390089">
            <a:off x="6536361" y="2014212"/>
            <a:ext cx="35137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NC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57B2AA4A-4DFE-A797-31A9-7D816EA25384}"/>
              </a:ext>
            </a:extLst>
          </p:cNvPr>
          <p:cNvSpPr txBox="1"/>
          <p:nvPr/>
        </p:nvSpPr>
        <p:spPr>
          <a:xfrm rot="19390089">
            <a:off x="6766009" y="1942262"/>
            <a:ext cx="60785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miR-145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C2D7CAB1-CA88-8F29-38AE-E9A9014FF697}"/>
              </a:ext>
            </a:extLst>
          </p:cNvPr>
          <p:cNvSpPr/>
          <p:nvPr/>
        </p:nvSpPr>
        <p:spPr>
          <a:xfrm>
            <a:off x="6502241" y="2223123"/>
            <a:ext cx="567698" cy="17851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393483DE-F8E9-35BE-7890-53E63509BB6F}"/>
              </a:ext>
            </a:extLst>
          </p:cNvPr>
          <p:cNvSpPr txBox="1"/>
          <p:nvPr/>
        </p:nvSpPr>
        <p:spPr>
          <a:xfrm>
            <a:off x="1731261" y="1884569"/>
            <a:ext cx="8100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2L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2CA93C2D-938D-F1FC-67AE-EFC859E70ADA}"/>
              </a:ext>
            </a:extLst>
          </p:cNvPr>
          <p:cNvSpPr txBox="1"/>
          <p:nvPr/>
        </p:nvSpPr>
        <p:spPr>
          <a:xfrm>
            <a:off x="7947036" y="2151864"/>
            <a:ext cx="1161928" cy="2497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1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-92kDa β-catenin</a:t>
            </a:r>
            <a:endParaRPr lang="zh-CN" altLang="zh-CN" sz="11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8888057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2020-10-01_04-36-33_8bit">
            <a:extLst>
              <a:ext uri="{FF2B5EF4-FFF2-40B4-BE49-F238E27FC236}">
                <a16:creationId xmlns:a16="http://schemas.microsoft.com/office/drawing/2014/main" id="{25D9DBB7-546C-BC32-AD96-B11F2C53991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lum contrast="-18000"/>
          </a:blip>
          <a:srcRect l="-108" t="249" r="123" b="-271"/>
          <a:stretch/>
        </p:blipFill>
        <p:spPr>
          <a:xfrm>
            <a:off x="1723096" y="1925391"/>
            <a:ext cx="8254800" cy="1998000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481BB593-C9D3-184A-2475-5E61FC64F93B}"/>
              </a:ext>
            </a:extLst>
          </p:cNvPr>
          <p:cNvSpPr txBox="1"/>
          <p:nvPr/>
        </p:nvSpPr>
        <p:spPr>
          <a:xfrm>
            <a:off x="7862767" y="2628580"/>
            <a:ext cx="116891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1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-36kDa GAPDH</a:t>
            </a:r>
            <a:endParaRPr lang="zh-CN" altLang="zh-CN" sz="11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4E822C1F-D73E-6FDB-9828-C4F8DA1B96D1}"/>
              </a:ext>
            </a:extLst>
          </p:cNvPr>
          <p:cNvSpPr txBox="1"/>
          <p:nvPr/>
        </p:nvSpPr>
        <p:spPr>
          <a:xfrm rot="19390089">
            <a:off x="6454718" y="2441344"/>
            <a:ext cx="35137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NC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57B2AA4A-4DFE-A797-31A9-7D816EA25384}"/>
              </a:ext>
            </a:extLst>
          </p:cNvPr>
          <p:cNvSpPr txBox="1"/>
          <p:nvPr/>
        </p:nvSpPr>
        <p:spPr>
          <a:xfrm rot="19390089">
            <a:off x="6684366" y="2369394"/>
            <a:ext cx="60785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miR-145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C2D7CAB1-CA88-8F29-38AE-E9A9014FF697}"/>
              </a:ext>
            </a:extLst>
          </p:cNvPr>
          <p:cNvSpPr/>
          <p:nvPr/>
        </p:nvSpPr>
        <p:spPr>
          <a:xfrm>
            <a:off x="6420598" y="2650255"/>
            <a:ext cx="567698" cy="17851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393483DE-F8E9-35BE-7890-53E63509BB6F}"/>
              </a:ext>
            </a:extLst>
          </p:cNvPr>
          <p:cNvSpPr txBox="1"/>
          <p:nvPr/>
        </p:nvSpPr>
        <p:spPr>
          <a:xfrm>
            <a:off x="1723096" y="1925391"/>
            <a:ext cx="8100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2L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7767613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图片 11" descr="2020-09-02_06-51-29_8bit">
            <a:extLst>
              <a:ext uri="{FF2B5EF4-FFF2-40B4-BE49-F238E27FC236}">
                <a16:creationId xmlns:a16="http://schemas.microsoft.com/office/drawing/2014/main" id="{EA7474BF-86A5-36B0-56D2-DEA44AB6A6E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lum bright="6000" contrast="-42000"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3000"/>
                    </a14:imgEffect>
                  </a14:imgLayer>
                </a14:imgProps>
              </a:ext>
            </a:extLst>
          </a:blip>
          <a:srcRect l="-134" t="-1" r="140" b="872"/>
          <a:stretch/>
        </p:blipFill>
        <p:spPr>
          <a:xfrm>
            <a:off x="1355826" y="1876243"/>
            <a:ext cx="9048452" cy="2189571"/>
          </a:xfrm>
          <a:prstGeom prst="rect">
            <a:avLst/>
          </a:prstGeom>
          <a:ln>
            <a:noFill/>
          </a:ln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FD76FFD3-8841-C89B-C7CE-5069F5913D2B}"/>
              </a:ext>
            </a:extLst>
          </p:cNvPr>
          <p:cNvSpPr txBox="1"/>
          <p:nvPr/>
        </p:nvSpPr>
        <p:spPr>
          <a:xfrm rot="19390089">
            <a:off x="4591171" y="2798054"/>
            <a:ext cx="58221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altLang="zh-CN" sz="9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nti-NC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66C19091-3288-E736-DB8B-3D6D2EC87EA2}"/>
              </a:ext>
            </a:extLst>
          </p:cNvPr>
          <p:cNvSpPr txBox="1"/>
          <p:nvPr/>
        </p:nvSpPr>
        <p:spPr>
          <a:xfrm rot="19390089">
            <a:off x="4874731" y="2721178"/>
            <a:ext cx="8386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nti-miR-145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9" name="矩形 8">
            <a:extLst>
              <a:ext uri="{FF2B5EF4-FFF2-40B4-BE49-F238E27FC236}">
                <a16:creationId xmlns:a16="http://schemas.microsoft.com/office/drawing/2014/main" id="{352AEC19-A9A8-34F3-DE5C-7A7A60BC7818}"/>
              </a:ext>
            </a:extLst>
          </p:cNvPr>
          <p:cNvSpPr/>
          <p:nvPr/>
        </p:nvSpPr>
        <p:spPr>
          <a:xfrm>
            <a:off x="4643251" y="3091102"/>
            <a:ext cx="567698" cy="17851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A1B8F0C5-18CC-6C8F-8860-C4CC443FB5D0}"/>
              </a:ext>
            </a:extLst>
          </p:cNvPr>
          <p:cNvSpPr txBox="1"/>
          <p:nvPr/>
        </p:nvSpPr>
        <p:spPr>
          <a:xfrm>
            <a:off x="5493623" y="3063815"/>
            <a:ext cx="1161928" cy="2497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1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-92kDa β-catenin</a:t>
            </a:r>
            <a:endParaRPr lang="zh-CN" altLang="zh-CN" sz="11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B335E63A-E43B-6C15-12CF-6921F6A49391}"/>
              </a:ext>
            </a:extLst>
          </p:cNvPr>
          <p:cNvSpPr txBox="1"/>
          <p:nvPr/>
        </p:nvSpPr>
        <p:spPr>
          <a:xfrm>
            <a:off x="1355826" y="1876243"/>
            <a:ext cx="8100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2M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8402037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图片 11" descr="2020-09-02_06-51-29_8bit">
            <a:extLst>
              <a:ext uri="{FF2B5EF4-FFF2-40B4-BE49-F238E27FC236}">
                <a16:creationId xmlns:a16="http://schemas.microsoft.com/office/drawing/2014/main" id="{EA7474BF-86A5-36B0-56D2-DEA44AB6A6E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lum bright="6000" contrast="-42000"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3000"/>
                    </a14:imgEffect>
                  </a14:imgLayer>
                </a14:imgProps>
              </a:ext>
            </a:extLst>
          </a:blip>
          <a:srcRect l="-134" t="-1" r="140" b="872"/>
          <a:stretch/>
        </p:blipFill>
        <p:spPr>
          <a:xfrm>
            <a:off x="1396647" y="2047693"/>
            <a:ext cx="9048452" cy="2189571"/>
          </a:xfrm>
          <a:prstGeom prst="rect">
            <a:avLst/>
          </a:prstGeom>
          <a:ln>
            <a:noFill/>
          </a:ln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FD76FFD3-8841-C89B-C7CE-5069F5913D2B}"/>
              </a:ext>
            </a:extLst>
          </p:cNvPr>
          <p:cNvSpPr txBox="1"/>
          <p:nvPr/>
        </p:nvSpPr>
        <p:spPr>
          <a:xfrm rot="19390089">
            <a:off x="4742576" y="3449462"/>
            <a:ext cx="58221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altLang="zh-CN" sz="9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nti-NC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66C19091-3288-E736-DB8B-3D6D2EC87EA2}"/>
              </a:ext>
            </a:extLst>
          </p:cNvPr>
          <p:cNvSpPr txBox="1"/>
          <p:nvPr/>
        </p:nvSpPr>
        <p:spPr>
          <a:xfrm rot="19390089">
            <a:off x="5031988" y="3386356"/>
            <a:ext cx="8386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nti-miR-145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3" name="矩形 12">
            <a:extLst>
              <a:ext uri="{FF2B5EF4-FFF2-40B4-BE49-F238E27FC236}">
                <a16:creationId xmlns:a16="http://schemas.microsoft.com/office/drawing/2014/main" id="{AFCCAB12-77B1-ACB4-F1CB-9EF0C19678E8}"/>
              </a:ext>
            </a:extLst>
          </p:cNvPr>
          <p:cNvSpPr/>
          <p:nvPr/>
        </p:nvSpPr>
        <p:spPr>
          <a:xfrm>
            <a:off x="4767199" y="3742509"/>
            <a:ext cx="567698" cy="17851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AC67B20D-6B1A-6F57-EFA4-D6BD9394D7C5}"/>
              </a:ext>
            </a:extLst>
          </p:cNvPr>
          <p:cNvSpPr txBox="1"/>
          <p:nvPr/>
        </p:nvSpPr>
        <p:spPr>
          <a:xfrm>
            <a:off x="5605705" y="3714730"/>
            <a:ext cx="116891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1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-36kDa GAPDH</a:t>
            </a:r>
            <a:endParaRPr lang="zh-CN" altLang="zh-CN" sz="11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B335E63A-E43B-6C15-12CF-6921F6A49391}"/>
              </a:ext>
            </a:extLst>
          </p:cNvPr>
          <p:cNvSpPr txBox="1"/>
          <p:nvPr/>
        </p:nvSpPr>
        <p:spPr>
          <a:xfrm>
            <a:off x="1396647" y="2047693"/>
            <a:ext cx="8100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2M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8579763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图片 8">
            <a:extLst>
              <a:ext uri="{FF2B5EF4-FFF2-40B4-BE49-F238E27FC236}">
                <a16:creationId xmlns:a16="http://schemas.microsoft.com/office/drawing/2014/main" id="{603A4977-3C48-1210-4032-CD5DE259FCE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09292" y="683847"/>
            <a:ext cx="5876732" cy="4426996"/>
          </a:xfrm>
          <a:prstGeom prst="rect">
            <a:avLst/>
          </a:prstGeom>
        </p:spPr>
      </p:pic>
      <p:sp>
        <p:nvSpPr>
          <p:cNvPr id="2" name="矩形 1">
            <a:extLst>
              <a:ext uri="{FF2B5EF4-FFF2-40B4-BE49-F238E27FC236}">
                <a16:creationId xmlns:a16="http://schemas.microsoft.com/office/drawing/2014/main" id="{9C5F77C5-21AA-C597-8851-4A649842A1AF}"/>
              </a:ext>
            </a:extLst>
          </p:cNvPr>
          <p:cNvSpPr/>
          <p:nvPr/>
        </p:nvSpPr>
        <p:spPr>
          <a:xfrm>
            <a:off x="6430186" y="2260635"/>
            <a:ext cx="1193418" cy="20247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8C8A47CB-EA2A-5EFB-5415-590B3C307011}"/>
              </a:ext>
            </a:extLst>
          </p:cNvPr>
          <p:cNvSpPr txBox="1"/>
          <p:nvPr/>
        </p:nvSpPr>
        <p:spPr>
          <a:xfrm rot="19390089">
            <a:off x="6481779" y="2023115"/>
            <a:ext cx="35137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NC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BA1A0FD7-FA87-112F-C7D4-99D79BDEDF77}"/>
              </a:ext>
            </a:extLst>
          </p:cNvPr>
          <p:cNvSpPr txBox="1"/>
          <p:nvPr/>
        </p:nvSpPr>
        <p:spPr>
          <a:xfrm rot="19390089">
            <a:off x="6722446" y="1959677"/>
            <a:ext cx="60785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miR-145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BC45D906-3D35-3E97-D5A7-764C07DC1BB1}"/>
              </a:ext>
            </a:extLst>
          </p:cNvPr>
          <p:cNvSpPr txBox="1"/>
          <p:nvPr/>
        </p:nvSpPr>
        <p:spPr>
          <a:xfrm rot="19390089">
            <a:off x="7030308" y="1952021"/>
            <a:ext cx="58221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altLang="zh-CN" sz="9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nti-NC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C2D56120-AE21-F5C2-F8A7-13FE0AD908FA}"/>
              </a:ext>
            </a:extLst>
          </p:cNvPr>
          <p:cNvSpPr txBox="1"/>
          <p:nvPr/>
        </p:nvSpPr>
        <p:spPr>
          <a:xfrm rot="19390089">
            <a:off x="7290211" y="1888583"/>
            <a:ext cx="80021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ntimiR-145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82BFE554-5F18-4ECA-FE2C-17113F9432E1}"/>
              </a:ext>
            </a:extLst>
          </p:cNvPr>
          <p:cNvSpPr txBox="1"/>
          <p:nvPr/>
        </p:nvSpPr>
        <p:spPr>
          <a:xfrm>
            <a:off x="8095555" y="2218863"/>
            <a:ext cx="11599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1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-</a:t>
            </a:r>
            <a:r>
              <a:rPr lang="en-US" altLang="zh-CN" sz="11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44</a:t>
            </a:r>
            <a:r>
              <a:rPr lang="en-US" altLang="zh-CN" sz="11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kDa WNT2B</a:t>
            </a:r>
            <a:endParaRPr lang="zh-CN" altLang="zh-CN" sz="1100" b="1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D2087981-40AC-6867-5E41-66A87B62E6CC}"/>
              </a:ext>
            </a:extLst>
          </p:cNvPr>
          <p:cNvSpPr txBox="1"/>
          <p:nvPr/>
        </p:nvSpPr>
        <p:spPr>
          <a:xfrm>
            <a:off x="3567560" y="683847"/>
            <a:ext cx="8100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3F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1474782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848728AB-A832-D5B0-CA5F-02901A40CF8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81678" y="1584001"/>
            <a:ext cx="5674439" cy="4274608"/>
          </a:xfrm>
          <a:prstGeom prst="rect">
            <a:avLst/>
          </a:prstGeom>
        </p:spPr>
      </p:pic>
      <p:sp>
        <p:nvSpPr>
          <p:cNvPr id="2" name="矩形 1">
            <a:extLst>
              <a:ext uri="{FF2B5EF4-FFF2-40B4-BE49-F238E27FC236}">
                <a16:creationId xmlns:a16="http://schemas.microsoft.com/office/drawing/2014/main" id="{11B10ACC-338B-6398-1812-5EF1113B08AC}"/>
              </a:ext>
            </a:extLst>
          </p:cNvPr>
          <p:cNvSpPr/>
          <p:nvPr/>
        </p:nvSpPr>
        <p:spPr>
          <a:xfrm>
            <a:off x="7036912" y="2431951"/>
            <a:ext cx="532287" cy="1893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C1C757AE-1525-196D-6A44-DADC9350395B}"/>
              </a:ext>
            </a:extLst>
          </p:cNvPr>
          <p:cNvSpPr/>
          <p:nvPr/>
        </p:nvSpPr>
        <p:spPr>
          <a:xfrm>
            <a:off x="5347333" y="2410392"/>
            <a:ext cx="532288" cy="1893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012E2F0D-99BC-6C81-EC72-4DE2EDEABD75}"/>
              </a:ext>
            </a:extLst>
          </p:cNvPr>
          <p:cNvSpPr txBox="1"/>
          <p:nvPr/>
        </p:nvSpPr>
        <p:spPr>
          <a:xfrm>
            <a:off x="7789559" y="2371344"/>
            <a:ext cx="123848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1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-</a:t>
            </a:r>
            <a:r>
              <a:rPr lang="en-US" altLang="zh-CN" sz="11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46</a:t>
            </a:r>
            <a:r>
              <a:rPr lang="en-US" altLang="zh-CN" sz="11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kDa WNT10A</a:t>
            </a:r>
            <a:endParaRPr lang="zh-CN" altLang="zh-CN" sz="11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BE101938-5251-6C69-EA71-84AB2B83004C}"/>
              </a:ext>
            </a:extLst>
          </p:cNvPr>
          <p:cNvSpPr txBox="1"/>
          <p:nvPr/>
        </p:nvSpPr>
        <p:spPr>
          <a:xfrm rot="19390089">
            <a:off x="5381454" y="2058229"/>
            <a:ext cx="35137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NC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AC5938CA-4255-3114-8003-459D34F75BEA}"/>
              </a:ext>
            </a:extLst>
          </p:cNvPr>
          <p:cNvSpPr txBox="1"/>
          <p:nvPr/>
        </p:nvSpPr>
        <p:spPr>
          <a:xfrm rot="19390089">
            <a:off x="5622121" y="1994791"/>
            <a:ext cx="60785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miR-145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986D10B7-1E4E-2306-4806-11A046C52EF3}"/>
              </a:ext>
            </a:extLst>
          </p:cNvPr>
          <p:cNvSpPr txBox="1"/>
          <p:nvPr/>
        </p:nvSpPr>
        <p:spPr>
          <a:xfrm rot="19390089">
            <a:off x="6969574" y="2026182"/>
            <a:ext cx="58221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altLang="zh-CN" sz="9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nti-NC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93724176-80B3-F2A4-BF68-44593F64EB02}"/>
              </a:ext>
            </a:extLst>
          </p:cNvPr>
          <p:cNvSpPr txBox="1"/>
          <p:nvPr/>
        </p:nvSpPr>
        <p:spPr>
          <a:xfrm rot="19390089">
            <a:off x="7229477" y="1962744"/>
            <a:ext cx="80021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ntimiR-145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0" name="文本框 15">
            <a:extLst>
              <a:ext uri="{FF2B5EF4-FFF2-40B4-BE49-F238E27FC236}">
                <a16:creationId xmlns:a16="http://schemas.microsoft.com/office/drawing/2014/main" id="{D2087981-40AC-6867-5E41-66A87B62E6CC}"/>
              </a:ext>
            </a:extLst>
          </p:cNvPr>
          <p:cNvSpPr txBox="1"/>
          <p:nvPr/>
        </p:nvSpPr>
        <p:spPr>
          <a:xfrm>
            <a:off x="3281678" y="1584001"/>
            <a:ext cx="8100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3F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5295888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图片 12">
            <a:extLst>
              <a:ext uri="{FF2B5EF4-FFF2-40B4-BE49-F238E27FC236}">
                <a16:creationId xmlns:a16="http://schemas.microsoft.com/office/drawing/2014/main" id="{C3C6E6FC-36F0-C664-28DE-41783500DB3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70152" y="1203353"/>
            <a:ext cx="5945528" cy="4478822"/>
          </a:xfrm>
          <a:prstGeom prst="rect">
            <a:avLst/>
          </a:prstGeom>
        </p:spPr>
      </p:pic>
      <p:sp>
        <p:nvSpPr>
          <p:cNvPr id="2" name="矩形 1">
            <a:extLst>
              <a:ext uri="{FF2B5EF4-FFF2-40B4-BE49-F238E27FC236}">
                <a16:creationId xmlns:a16="http://schemas.microsoft.com/office/drawing/2014/main" id="{35D50B5F-8E24-FAFA-60F1-18BA85314033}"/>
              </a:ext>
            </a:extLst>
          </p:cNvPr>
          <p:cNvSpPr/>
          <p:nvPr/>
        </p:nvSpPr>
        <p:spPr>
          <a:xfrm>
            <a:off x="4803275" y="1723455"/>
            <a:ext cx="1231766" cy="22594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563FD2E4-B5C3-09D2-9247-806508CBD37E}"/>
              </a:ext>
            </a:extLst>
          </p:cNvPr>
          <p:cNvSpPr txBox="1"/>
          <p:nvPr/>
        </p:nvSpPr>
        <p:spPr>
          <a:xfrm>
            <a:off x="7542681" y="1723455"/>
            <a:ext cx="116891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1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-36kDa GAPDH</a:t>
            </a:r>
            <a:endParaRPr lang="zh-CN" altLang="zh-CN" sz="1100" b="1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3189B1C6-0CA5-2D2B-731A-6C394963D6FF}"/>
              </a:ext>
            </a:extLst>
          </p:cNvPr>
          <p:cNvSpPr txBox="1"/>
          <p:nvPr/>
        </p:nvSpPr>
        <p:spPr>
          <a:xfrm rot="19390089">
            <a:off x="4837396" y="1475801"/>
            <a:ext cx="35137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NC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2D52C3F3-7361-AA41-809D-F5AC3FCC17DD}"/>
              </a:ext>
            </a:extLst>
          </p:cNvPr>
          <p:cNvSpPr txBox="1"/>
          <p:nvPr/>
        </p:nvSpPr>
        <p:spPr>
          <a:xfrm rot="19390089">
            <a:off x="5078063" y="1412363"/>
            <a:ext cx="60785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miR-145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4497FFF4-FDF3-F08A-367C-272AE7CDEB00}"/>
              </a:ext>
            </a:extLst>
          </p:cNvPr>
          <p:cNvSpPr txBox="1"/>
          <p:nvPr/>
        </p:nvSpPr>
        <p:spPr>
          <a:xfrm rot="19390089">
            <a:off x="5385925" y="1404707"/>
            <a:ext cx="58221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altLang="zh-CN" sz="9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nti-NC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BB144A29-265D-F06C-568B-40E313B5F952}"/>
              </a:ext>
            </a:extLst>
          </p:cNvPr>
          <p:cNvSpPr txBox="1"/>
          <p:nvPr/>
        </p:nvSpPr>
        <p:spPr>
          <a:xfrm rot="19390089">
            <a:off x="5676624" y="1341064"/>
            <a:ext cx="80021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ntimiR-145</a:t>
            </a:r>
            <a:endParaRPr lang="zh-CN" altLang="zh-CN" sz="9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1" name="文本框 15">
            <a:extLst>
              <a:ext uri="{FF2B5EF4-FFF2-40B4-BE49-F238E27FC236}">
                <a16:creationId xmlns:a16="http://schemas.microsoft.com/office/drawing/2014/main" id="{D2087981-40AC-6867-5E41-66A87B62E6CC}"/>
              </a:ext>
            </a:extLst>
          </p:cNvPr>
          <p:cNvSpPr txBox="1"/>
          <p:nvPr/>
        </p:nvSpPr>
        <p:spPr>
          <a:xfrm>
            <a:off x="2651187" y="1259508"/>
            <a:ext cx="8100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3F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277965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70</TotalTime>
  <Words>232</Words>
  <Application>Microsoft Office PowerPoint</Application>
  <PresentationFormat>宽屏</PresentationFormat>
  <Paragraphs>108</Paragraphs>
  <Slides>20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0</vt:i4>
      </vt:variant>
    </vt:vector>
  </HeadingPairs>
  <TitlesOfParts>
    <vt:vector size="25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dengliqiang02@outlook.com</dc:creator>
  <cp:lastModifiedBy>dengliqiang02@outlook.com</cp:lastModifiedBy>
  <cp:revision>8</cp:revision>
  <dcterms:created xsi:type="dcterms:W3CDTF">2024-07-09T00:48:07Z</dcterms:created>
  <dcterms:modified xsi:type="dcterms:W3CDTF">2024-08-04T11:17:43Z</dcterms:modified>
</cp:coreProperties>
</file>